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814A0-775C-4B21-A1E8-E50C21844A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0D80A-7199-4B7A-8F5A-70CD23BB92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1DEF0-579C-407E-B4B6-8602FE6A22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EBDAB-0E4E-4BFB-82A6-4AB5D7FD06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8AC85-0C84-4D63-8FA4-0E74409B5C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1C43B-A370-4A99-BB84-931E32F952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A4F6B-44D3-4C00-9637-FD5841312A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35222-C655-40B1-A4B1-30AA077B45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0" y="-36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23B51-DA04-403B-8BEA-D251FD1524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7A2A1-16D3-4D05-B11E-54E38B79F4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D207D-DDE4-42AB-9752-CDA3529F68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AA5AF-FB7B-4B4B-8125-FC32E3A19E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Comic Sans MS"/>
              </a:rPr>
              <a:t>Click to edit the title text format</a:t>
            </a:r>
            <a:endParaRPr b="0" lang="en-US" sz="24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00"/>
              </a:spcBef>
              <a:buClr>
                <a:srgbClr val="0000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Comic Sans MS"/>
              </a:rPr>
              <a:t>Click to edit the outline text format</a:t>
            </a: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  <a:p>
            <a:pPr lvl="1" marL="743040" indent="-285840">
              <a:spcBef>
                <a:spcPts val="400"/>
              </a:spcBef>
              <a:buClr>
                <a:srgbClr val="0000ff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Comic Sans MS"/>
              </a:rPr>
              <a:t>Second Outline Level</a:t>
            </a: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  <a:p>
            <a:pPr lvl="2" marL="1143000" indent="-228600">
              <a:spcBef>
                <a:spcPts val="400"/>
              </a:spcBef>
              <a:buClr>
                <a:srgbClr val="0000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Comic Sans MS"/>
              </a:rPr>
              <a:t>Third Outline Level</a:t>
            </a: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  <a:p>
            <a:pPr lvl="3" marL="1600200" indent="-228600">
              <a:spcBef>
                <a:spcPts val="400"/>
              </a:spcBef>
              <a:buClr>
                <a:srgbClr val="0000ff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Comic Sans MS"/>
              </a:rPr>
              <a:t>Fourth Outline Level</a:t>
            </a: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  <a:p>
            <a:pPr lvl="4" marL="2057400" indent="-228600">
              <a:spcBef>
                <a:spcPts val="400"/>
              </a:spcBef>
              <a:buClr>
                <a:srgbClr val="0000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Comic Sans MS"/>
              </a:rPr>
              <a:t>Fifth Outline Level</a:t>
            </a: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  <a:p>
            <a:pPr lvl="5" marL="2057400" indent="-22860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Comic Sans MS"/>
              </a:rPr>
              <a:t>Sixth Outline Level</a:t>
            </a: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  <a:p>
            <a:pPr lvl="6" marL="2057400" indent="-22860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Comic Sans MS"/>
              </a:rPr>
              <a:t>Seventh Outline Level</a:t>
            </a:r>
            <a:endParaRPr b="0" lang="en-US" sz="1600" spc="-1" strike="noStrike">
              <a:solidFill>
                <a:srgbClr val="0000ff"/>
              </a:solidFill>
              <a:latin typeface="Comic Sans M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ff"/>
                </a:solidFill>
                <a:latin typeface="Comic Sans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ff"/>
                </a:solidFill>
                <a:latin typeface="Comic Sans M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ff"/>
                </a:solidFill>
                <a:latin typeface="Comic Sans M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7937B8-6DC2-4648-AC0D-FBB5AE5A28A0}" type="slidenum">
              <a:rPr b="0" lang="en-US" sz="1200" spc="-1" strike="noStrike">
                <a:solidFill>
                  <a:srgbClr val="0000ff"/>
                </a:solidFill>
                <a:latin typeface="Comic Sans M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0" y="3505320"/>
            <a:ext cx="9144000" cy="170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S2 Recoveries of the DXP pathway intermediates through solid phase extrac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Recoveries of all the commercially available DXP pathway intermediates (DXP, MEP, CDP-ME, MEC and HMBPP) through the solid phase extraction were characterized. The standards were spiked into 1 mL the acidic extraction solution in concentration of 1 µM. The intermediates were purified from the solution and quantified as described. The recoveries were at least 40% for all the intermediates. Presented data were average of triplicates and standard errors were drawn on the plo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hart 3" descr=""/>
          <p:cNvPicPr/>
          <p:nvPr/>
        </p:nvPicPr>
        <p:blipFill>
          <a:blip r:embed="rId1"/>
          <a:stretch/>
        </p:blipFill>
        <p:spPr>
          <a:xfrm>
            <a:off x="2212920" y="689040"/>
            <a:ext cx="4565880" cy="2644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4T03:21:10Z</dcterms:created>
  <dc:creator>Kang</dc:creator>
  <dc:description/>
  <dc:language>en-US</dc:language>
  <cp:lastModifiedBy>Kang</cp:lastModifiedBy>
  <dcterms:modified xsi:type="dcterms:W3CDTF">2012-05-17T13:59:01Z</dcterms:modified>
  <cp:revision>268</cp:revision>
  <dc:subject/>
  <dc:title>PowerPoint Presentation</dc:title>
</cp:coreProperties>
</file>